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70" d="100"/>
          <a:sy n="70" d="100"/>
        </p:scale>
        <p:origin x="141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 smtClean="0"/>
              <a:t>Образец подзаголовка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2CD3F-0974-4696-B652-6DCF718527DF}" type="datetimeFigureOut">
              <a:rPr lang="ru-RU" smtClean="0"/>
              <a:t>30.05.2021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49FC0-8646-4440-A790-686834A91B4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863790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2CD3F-0974-4696-B652-6DCF718527DF}" type="datetimeFigureOut">
              <a:rPr lang="ru-RU" smtClean="0"/>
              <a:t>30.05.2021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49FC0-8646-4440-A790-686834A91B4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1120297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2CD3F-0974-4696-B652-6DCF718527DF}" type="datetimeFigureOut">
              <a:rPr lang="ru-RU" smtClean="0"/>
              <a:t>30.05.2021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49FC0-8646-4440-A790-686834A91B4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614543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2CD3F-0974-4696-B652-6DCF718527DF}" type="datetimeFigureOut">
              <a:rPr lang="ru-RU" smtClean="0"/>
              <a:t>30.05.2021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49FC0-8646-4440-A790-686834A91B4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908262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2CD3F-0974-4696-B652-6DCF718527DF}" type="datetimeFigureOut">
              <a:rPr lang="ru-RU" smtClean="0"/>
              <a:t>30.05.2021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49FC0-8646-4440-A790-686834A91B4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424935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2CD3F-0974-4696-B652-6DCF718527DF}" type="datetimeFigureOut">
              <a:rPr lang="ru-RU" smtClean="0"/>
              <a:t>30.05.2021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49FC0-8646-4440-A790-686834A91B4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213247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2CD3F-0974-4696-B652-6DCF718527DF}" type="datetimeFigureOut">
              <a:rPr lang="ru-RU" smtClean="0"/>
              <a:t>30.05.2021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49FC0-8646-4440-A790-686834A91B4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632733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2CD3F-0974-4696-B652-6DCF718527DF}" type="datetimeFigureOut">
              <a:rPr lang="ru-RU" smtClean="0"/>
              <a:t>30.05.2021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49FC0-8646-4440-A790-686834A91B4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232486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2CD3F-0974-4696-B652-6DCF718527DF}" type="datetimeFigureOut">
              <a:rPr lang="ru-RU" smtClean="0"/>
              <a:t>30.05.2021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49FC0-8646-4440-A790-686834A91B4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203149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2CD3F-0974-4696-B652-6DCF718527DF}" type="datetimeFigureOut">
              <a:rPr lang="ru-RU" smtClean="0"/>
              <a:t>30.05.2021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49FC0-8646-4440-A790-686834A91B4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927707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ru-RU" smtClean="0"/>
              <a:t>Вставка рисунка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2CD3F-0974-4696-B652-6DCF718527DF}" type="datetimeFigureOut">
              <a:rPr lang="ru-RU" smtClean="0"/>
              <a:t>30.05.2021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49FC0-8646-4440-A790-686834A91B4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9899835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32CD3F-0974-4696-B652-6DCF718527DF}" type="datetimeFigureOut">
              <a:rPr lang="ru-RU" smtClean="0"/>
              <a:t>30.05.2021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849FC0-8646-4440-A790-686834A91B4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803650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45661" y="5595582"/>
            <a:ext cx="866632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dirty="0" smtClean="0"/>
              <a:t>Figure S2. The hybrid</a:t>
            </a:r>
            <a:r>
              <a:rPr lang="en-US" dirty="0" smtClean="0"/>
              <a:t> М.№3-11-2-41 </a:t>
            </a:r>
            <a:r>
              <a:rPr lang="en-US" dirty="0" smtClean="0"/>
              <a:t>from the </a:t>
            </a:r>
            <a:r>
              <a:rPr lang="en-US" dirty="0"/>
              <a:t>population 3-11 (♀М.№31-77-10 х 2000-305-143) </a:t>
            </a:r>
            <a:r>
              <a:rPr lang="en-US" dirty="0" smtClean="0"/>
              <a:t>with outstanding </a:t>
            </a:r>
            <a:r>
              <a:rPr lang="en-US" dirty="0" err="1" smtClean="0"/>
              <a:t>agrobiological</a:t>
            </a:r>
            <a:r>
              <a:rPr lang="en-US" dirty="0" smtClean="0"/>
              <a:t> characteristics: the </a:t>
            </a:r>
            <a:r>
              <a:rPr lang="en-US" dirty="0"/>
              <a:t>highest score of resistance to powdery mildew, the average mass of bunches 241 g (maximal – 662 g), and very high average yield (349 g) per </a:t>
            </a:r>
            <a:r>
              <a:rPr lang="en-US" dirty="0" smtClean="0"/>
              <a:t>shoot. </a:t>
            </a:r>
            <a:endParaRPr lang="ru-RU" dirty="0"/>
          </a:p>
        </p:txBody>
      </p:sp>
      <p:grpSp>
        <p:nvGrpSpPr>
          <p:cNvPr id="13" name="Группа 12"/>
          <p:cNvGrpSpPr/>
          <p:nvPr/>
        </p:nvGrpSpPr>
        <p:grpSpPr>
          <a:xfrm>
            <a:off x="423079" y="311503"/>
            <a:ext cx="6874110" cy="5184596"/>
            <a:chOff x="423079" y="311503"/>
            <a:chExt cx="6874110" cy="5184596"/>
          </a:xfrm>
        </p:grpSpPr>
        <p:pic>
          <p:nvPicPr>
            <p:cNvPr id="4" name="Рисунок 3"/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22218" y="311503"/>
              <a:ext cx="5674971" cy="5184596"/>
            </a:xfrm>
            <a:prstGeom prst="rect">
              <a:avLst/>
            </a:prstGeom>
            <a:noFill/>
            <a:ln>
              <a:noFill/>
            </a:ln>
          </p:spPr>
        </p:pic>
        <p:cxnSp>
          <p:nvCxnSpPr>
            <p:cNvPr id="7" name="Прямая соединительная линия 6"/>
            <p:cNvCxnSpPr/>
            <p:nvPr/>
          </p:nvCxnSpPr>
          <p:spPr>
            <a:xfrm>
              <a:off x="1064528" y="5308979"/>
              <a:ext cx="51861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" name="Прямая соединительная линия 7"/>
            <p:cNvCxnSpPr/>
            <p:nvPr/>
          </p:nvCxnSpPr>
          <p:spPr>
            <a:xfrm>
              <a:off x="1094096" y="3728112"/>
              <a:ext cx="51861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Прямая соединительная линия 8"/>
            <p:cNvCxnSpPr/>
            <p:nvPr/>
          </p:nvCxnSpPr>
          <p:spPr>
            <a:xfrm>
              <a:off x="1123664" y="2201834"/>
              <a:ext cx="51861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423079" y="1983467"/>
              <a:ext cx="7537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20 cm</a:t>
              </a:r>
              <a:endParaRPr lang="ru-RU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25354" y="3527947"/>
              <a:ext cx="7537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10 cm</a:t>
              </a:r>
              <a:endParaRPr lang="ru-RU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95870" y="5099721"/>
              <a:ext cx="63671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0 cm</a:t>
              </a:r>
              <a:endParaRPr lang="ru-RU" dirty="0"/>
            </a:p>
          </p:txBody>
        </p:sp>
      </p:grpSp>
    </p:spTree>
    <p:extLst>
      <p:ext uri="{BB962C8B-B14F-4D97-AF65-F5344CB8AC3E}">
        <p14:creationId xmlns:p14="http://schemas.microsoft.com/office/powerpoint/2010/main" val="29171995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Тема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Тема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Тема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67</Words>
  <Application>Microsoft Office PowerPoint</Application>
  <PresentationFormat>Экран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3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Тема Office</vt:lpstr>
      <vt:lpstr>Презентация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Elena</dc:creator>
  <cp:lastModifiedBy>Elena</cp:lastModifiedBy>
  <cp:revision>2</cp:revision>
  <dcterms:created xsi:type="dcterms:W3CDTF">2021-05-30T06:53:13Z</dcterms:created>
  <dcterms:modified xsi:type="dcterms:W3CDTF">2021-05-30T07:11:51Z</dcterms:modified>
</cp:coreProperties>
</file>